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5698" autoAdjust="0"/>
  </p:normalViewPr>
  <p:slideViewPr>
    <p:cSldViewPr>
      <p:cViewPr varScale="1">
        <p:scale>
          <a:sx n="62" d="100"/>
          <a:sy n="62" d="100"/>
        </p:scale>
        <p:origin x="1626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E1626A-E5DB-4888-B6E9-B84407C3E8EF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6D5A9F-0F10-4483-BDCF-6A090BBB42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1540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3:</a:t>
            </a:r>
            <a:r>
              <a:rPr lang="en-US" baseline="0" dirty="0"/>
              <a:t> 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romosomal microarray performed on DNA extracted from FFPE tissue using the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coSca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NV Plus assay for ETT-3</a:t>
            </a:r>
            <a:endParaRPr lang="en-US" dirty="0"/>
          </a:p>
          <a:p>
            <a:endParaRPr lang="en-US" dirty="0"/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TT-3 was classified as negative for genomic deletions affecting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PCAT1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r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ERT,</a:t>
            </a:r>
            <a:r>
              <a:rPr lang="en-US" sz="1200" i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ut demonstrated copy number gain of chromosome 5.</a:t>
            </a:r>
            <a:endParaRPr lang="en-US" i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6D5A9F-0F10-4483-BDCF-6A090BBB428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6675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285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215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68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217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150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299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08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284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724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511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437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278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3" name="Picture 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130" y="4495800"/>
            <a:ext cx="885677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9201" y="152400"/>
            <a:ext cx="7866934" cy="426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ctangle 4"/>
          <p:cNvSpPr/>
          <p:nvPr/>
        </p:nvSpPr>
        <p:spPr>
          <a:xfrm>
            <a:off x="381000" y="368595"/>
            <a:ext cx="71199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ETT-3</a:t>
            </a:r>
          </a:p>
        </p:txBody>
      </p:sp>
      <p:sp>
        <p:nvSpPr>
          <p:cNvPr id="2" name="Rectangle 1"/>
          <p:cNvSpPr/>
          <p:nvPr/>
        </p:nvSpPr>
        <p:spPr>
          <a:xfrm>
            <a:off x="106131" y="5619571"/>
            <a:ext cx="898000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/>
              <a:t>S3 Fig:  </a:t>
            </a:r>
            <a:r>
              <a:rPr lang="en-US" dirty="0"/>
              <a:t>Chromosomal microarray performed on DNA extracted from FFPE tissue using the </a:t>
            </a:r>
            <a:r>
              <a:rPr lang="en-US" dirty="0" err="1"/>
              <a:t>OncoScan</a:t>
            </a:r>
            <a:r>
              <a:rPr lang="en-US" dirty="0"/>
              <a:t> CNV Plus assay for ETT-3.  ETT-3 was classified as negative for genomic deletions affecting </a:t>
            </a:r>
            <a:r>
              <a:rPr lang="en-US" i="1" dirty="0"/>
              <a:t>LPCAT1 </a:t>
            </a:r>
            <a:r>
              <a:rPr lang="en-US" dirty="0"/>
              <a:t>or </a:t>
            </a:r>
            <a:r>
              <a:rPr lang="en-US" i="1" dirty="0"/>
              <a:t>TERT, </a:t>
            </a:r>
            <a:r>
              <a:rPr lang="en-US" dirty="0"/>
              <a:t> but demonstrated copy number gain of chromosome 5.</a:t>
            </a:r>
          </a:p>
        </p:txBody>
      </p:sp>
    </p:spTree>
    <p:extLst>
      <p:ext uri="{BB962C8B-B14F-4D97-AF65-F5344CB8AC3E}">
        <p14:creationId xmlns:p14="http://schemas.microsoft.com/office/powerpoint/2010/main" val="28049043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0</TotalTime>
  <Words>88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e L Hoppman</dc:creator>
  <cp:lastModifiedBy>chn off31</cp:lastModifiedBy>
  <cp:revision>19</cp:revision>
  <dcterms:created xsi:type="dcterms:W3CDTF">2019-10-11T15:47:09Z</dcterms:created>
  <dcterms:modified xsi:type="dcterms:W3CDTF">2021-05-15T05:14:39Z</dcterms:modified>
</cp:coreProperties>
</file>